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907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5767E7-6A54-4265-8297-758F9EB2AA5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5ED574-3034-4775-9E84-00DF6217536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1C7B64-66BE-479E-8D13-801A344A015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0964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52428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9500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0964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52428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05D587-A035-43E6-842E-CA021AB8C25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5AF752-49FD-4655-9D14-346BF026285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FE5700-F1BE-417C-A6F6-7A9BDEEAE86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E62561-394E-4959-A574-F0C4EC97385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1C28E1-1A4C-4246-B9DE-E6CB8D4AAF2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95000" y="274320"/>
            <a:ext cx="8915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11EBDE-CF62-4500-A757-DCC3E442F57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AA1BFE-FAA7-4909-9CCD-66A1E4A02F8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81275B-9CC0-46BD-BFD2-D80CBCE809E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AED686-73C7-4D10-82F7-1F81D641051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95360" y="6356520"/>
            <a:ext cx="2311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384360" y="6356520"/>
            <a:ext cx="31366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098840" y="6356520"/>
            <a:ext cx="23115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1B16D13-9BF0-44FA-BDB5-0877140D1255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テキスト ボックス 4"/>
          <p:cNvSpPr/>
          <p:nvPr/>
        </p:nvSpPr>
        <p:spPr>
          <a:xfrm>
            <a:off x="3674160" y="4335480"/>
            <a:ext cx="3697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-acti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テキスト ボックス 5"/>
          <p:cNvSpPr/>
          <p:nvPr/>
        </p:nvSpPr>
        <p:spPr>
          <a:xfrm>
            <a:off x="3449520" y="4025880"/>
            <a:ext cx="5936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E-cadheri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テキスト ボックス 1349"/>
          <p:cNvSpPr/>
          <p:nvPr/>
        </p:nvSpPr>
        <p:spPr>
          <a:xfrm>
            <a:off x="3907440" y="337248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テキスト ボックス 1350"/>
          <p:cNvSpPr/>
          <p:nvPr/>
        </p:nvSpPr>
        <p:spPr>
          <a:xfrm>
            <a:off x="3907440" y="307512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6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テキスト ボックス 1351"/>
          <p:cNvSpPr/>
          <p:nvPr/>
        </p:nvSpPr>
        <p:spPr>
          <a:xfrm>
            <a:off x="3907440" y="356148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テキスト ボックス 1352"/>
          <p:cNvSpPr/>
          <p:nvPr/>
        </p:nvSpPr>
        <p:spPr>
          <a:xfrm>
            <a:off x="3907440" y="367596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テキスト ボックス 1353"/>
          <p:cNvSpPr/>
          <p:nvPr/>
        </p:nvSpPr>
        <p:spPr>
          <a:xfrm>
            <a:off x="3850920" y="128664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2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テキスト ボックス 1357"/>
          <p:cNvSpPr/>
          <p:nvPr/>
        </p:nvSpPr>
        <p:spPr>
          <a:xfrm>
            <a:off x="3850920" y="248364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1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テキスト ボックス 246"/>
          <p:cNvSpPr/>
          <p:nvPr/>
        </p:nvSpPr>
        <p:spPr>
          <a:xfrm rot="16200000">
            <a:off x="2550600" y="2473200"/>
            <a:ext cx="2224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HGSｺﾞｼｯｸE"/>
              </a:rPr>
              <a:t>Relative expression ratio of </a:t>
            </a:r>
            <a:r>
              <a:rPr b="1" i="1" lang="en-US" sz="900" spc="-1" strike="noStrike">
                <a:solidFill>
                  <a:srgbClr val="000000"/>
                </a:solidFill>
                <a:latin typeface="Arial"/>
                <a:ea typeface="HGSｺﾞｼｯｸE"/>
              </a:rPr>
              <a:t>CDH1 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  <a:ea typeface="HGSｺﾞｼｯｸE"/>
              </a:rPr>
              <a:t>mRN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テキスト ボックス 1357"/>
          <p:cNvSpPr/>
          <p:nvPr/>
        </p:nvSpPr>
        <p:spPr>
          <a:xfrm>
            <a:off x="3850920" y="188748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18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直線コネクタ 42"/>
          <p:cNvSpPr/>
          <p:nvPr/>
        </p:nvSpPr>
        <p:spPr>
          <a:xfrm>
            <a:off x="4008600" y="3433680"/>
            <a:ext cx="727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直線コネクタ 43"/>
          <p:cNvSpPr/>
          <p:nvPr/>
        </p:nvSpPr>
        <p:spPr>
          <a:xfrm>
            <a:off x="4008600" y="3137040"/>
            <a:ext cx="727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直線コネクタ 44"/>
          <p:cNvSpPr/>
          <p:nvPr/>
        </p:nvSpPr>
        <p:spPr>
          <a:xfrm>
            <a:off x="4008600" y="3733920"/>
            <a:ext cx="727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直線コネクタ 45"/>
          <p:cNvSpPr/>
          <p:nvPr/>
        </p:nvSpPr>
        <p:spPr>
          <a:xfrm>
            <a:off x="4008600" y="1349280"/>
            <a:ext cx="727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直線コネクタ 46"/>
          <p:cNvSpPr/>
          <p:nvPr/>
        </p:nvSpPr>
        <p:spPr>
          <a:xfrm>
            <a:off x="4008600" y="2541600"/>
            <a:ext cx="727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直線コネクタ 47"/>
          <p:cNvSpPr/>
          <p:nvPr/>
        </p:nvSpPr>
        <p:spPr>
          <a:xfrm>
            <a:off x="4008600" y="1947960"/>
            <a:ext cx="727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正方形/長方形 80"/>
          <p:cNvSpPr/>
          <p:nvPr/>
        </p:nvSpPr>
        <p:spPr>
          <a:xfrm>
            <a:off x="4081320" y="1349280"/>
            <a:ext cx="1871640" cy="238464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直線コネクタ 81"/>
          <p:cNvSpPr/>
          <p:nvPr/>
        </p:nvSpPr>
        <p:spPr>
          <a:xfrm>
            <a:off x="4078440" y="3633840"/>
            <a:ext cx="1871640" cy="0"/>
          </a:xfrm>
          <a:prstGeom prst="line">
            <a:avLst/>
          </a:prstGeom>
          <a:ln w="32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直線コネクタ 82"/>
          <p:cNvSpPr/>
          <p:nvPr/>
        </p:nvSpPr>
        <p:spPr>
          <a:xfrm>
            <a:off x="4008600" y="3633840"/>
            <a:ext cx="727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0" name="Picture 2" descr="C:\Users\MCG\Desktop\Harazono box\PLOS ONE\Revise\western data\TE8\20130305_TE8 NC 655 actb.img.tif"/>
          <p:cNvPicPr/>
          <p:nvPr/>
        </p:nvPicPr>
        <p:blipFill>
          <a:blip r:embed="rId1"/>
          <a:srcRect l="45821" t="50010" r="38135" b="41243"/>
          <a:stretch/>
        </p:blipFill>
        <p:spPr>
          <a:xfrm>
            <a:off x="4175280" y="4286160"/>
            <a:ext cx="779400" cy="285840"/>
          </a:xfrm>
          <a:prstGeom prst="rect">
            <a:avLst/>
          </a:prstGeom>
          <a:ln w="3240">
            <a:solidFill>
              <a:srgbClr val="000000"/>
            </a:solidFill>
            <a:miter/>
          </a:ln>
        </p:spPr>
      </p:pic>
      <p:pic>
        <p:nvPicPr>
          <p:cNvPr id="61" name="Picture 3" descr="C:\Users\MCG\Desktop\Harazono box\PLOS ONE\Revise\western data\TE8\20130306_TE8 NC 655 CDH1.img.tif"/>
          <p:cNvPicPr/>
          <p:nvPr/>
        </p:nvPicPr>
        <p:blipFill>
          <a:blip r:embed="rId2"/>
          <a:srcRect l="47598" t="46169" r="37808" b="45867"/>
          <a:stretch/>
        </p:blipFill>
        <p:spPr>
          <a:xfrm>
            <a:off x="4175280" y="3933720"/>
            <a:ext cx="779400" cy="284400"/>
          </a:xfrm>
          <a:prstGeom prst="rect">
            <a:avLst/>
          </a:prstGeom>
          <a:ln w="3240">
            <a:solidFill>
              <a:srgbClr val="000000"/>
            </a:solidFill>
            <a:miter/>
          </a:ln>
        </p:spPr>
      </p:pic>
      <p:sp>
        <p:nvSpPr>
          <p:cNvPr id="62" name="テキスト ボックス 88"/>
          <p:cNvSpPr/>
          <p:nvPr/>
        </p:nvSpPr>
        <p:spPr>
          <a:xfrm>
            <a:off x="4450320" y="5486400"/>
            <a:ext cx="2109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TE8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直線コネクタ 89"/>
          <p:cNvSpPr/>
          <p:nvPr/>
        </p:nvSpPr>
        <p:spPr>
          <a:xfrm>
            <a:off x="4167360" y="5375160"/>
            <a:ext cx="77760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テキスト ボックス 90"/>
          <p:cNvSpPr/>
          <p:nvPr/>
        </p:nvSpPr>
        <p:spPr>
          <a:xfrm rot="16200000">
            <a:off x="4117680" y="4924080"/>
            <a:ext cx="5918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ds-</a:t>
            </a:r>
            <a:r>
              <a:rPr b="1" i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miR-NC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テキスト ボックス 91"/>
          <p:cNvSpPr/>
          <p:nvPr/>
        </p:nvSpPr>
        <p:spPr>
          <a:xfrm rot="16200000">
            <a:off x="4388040" y="4936680"/>
            <a:ext cx="6195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ds</a:t>
            </a:r>
            <a:r>
              <a:rPr b="1" i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-miR-65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6" name="Picture 2" descr="C:\Users\MCG\Desktop\Harazono box\PLOS ONE\Revise\western data\HSC2\20130309_HSC2 MDAMB231 NC 655 actb.img.tif"/>
          <p:cNvPicPr/>
          <p:nvPr/>
        </p:nvPicPr>
        <p:blipFill>
          <a:blip r:embed="rId3"/>
          <a:srcRect l="25921" t="53118" r="58904" b="39130"/>
          <a:stretch/>
        </p:blipFill>
        <p:spPr>
          <a:xfrm>
            <a:off x="5089680" y="4286160"/>
            <a:ext cx="790560" cy="285840"/>
          </a:xfrm>
          <a:prstGeom prst="rect">
            <a:avLst/>
          </a:prstGeom>
          <a:ln w="3240">
            <a:solidFill>
              <a:srgbClr val="000000"/>
            </a:solidFill>
            <a:miter/>
          </a:ln>
        </p:spPr>
      </p:pic>
      <p:pic>
        <p:nvPicPr>
          <p:cNvPr id="67" name="Picture 3" descr="C:\Users\MCG\Desktop\Harazono box\PLOS ONE\Revise\western data\HSC2\20130309_HSC2 NC 655 CDH1.img.tif"/>
          <p:cNvPicPr/>
          <p:nvPr/>
        </p:nvPicPr>
        <p:blipFill>
          <a:blip r:embed="rId4"/>
          <a:srcRect l="46466" t="44055" r="38907" b="48742"/>
          <a:stretch/>
        </p:blipFill>
        <p:spPr>
          <a:xfrm>
            <a:off x="5089680" y="3933720"/>
            <a:ext cx="790560" cy="284400"/>
          </a:xfrm>
          <a:prstGeom prst="rect">
            <a:avLst/>
          </a:prstGeom>
          <a:ln w="3240">
            <a:solidFill>
              <a:srgbClr val="000000"/>
            </a:solidFill>
            <a:miter/>
          </a:ln>
        </p:spPr>
      </p:pic>
      <p:sp>
        <p:nvSpPr>
          <p:cNvPr id="68" name="テキスト ボックス 94"/>
          <p:cNvSpPr/>
          <p:nvPr/>
        </p:nvSpPr>
        <p:spPr>
          <a:xfrm>
            <a:off x="5336640" y="5486400"/>
            <a:ext cx="3056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HSC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直線コネクタ 95"/>
          <p:cNvSpPr/>
          <p:nvPr/>
        </p:nvSpPr>
        <p:spPr>
          <a:xfrm>
            <a:off x="5099040" y="5375160"/>
            <a:ext cx="77940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テキスト ボックス 96"/>
          <p:cNvSpPr/>
          <p:nvPr/>
        </p:nvSpPr>
        <p:spPr>
          <a:xfrm rot="16200000">
            <a:off x="5049720" y="4924080"/>
            <a:ext cx="5918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ds-</a:t>
            </a:r>
            <a:r>
              <a:rPr b="1" i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miR-NC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テキスト ボックス 97"/>
          <p:cNvSpPr/>
          <p:nvPr/>
        </p:nvSpPr>
        <p:spPr>
          <a:xfrm rot="16200000">
            <a:off x="5319720" y="4936680"/>
            <a:ext cx="6195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ds</a:t>
            </a:r>
            <a:r>
              <a:rPr b="1" i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-miR-65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直線コネクタ 102"/>
          <p:cNvSpPr/>
          <p:nvPr/>
        </p:nvSpPr>
        <p:spPr>
          <a:xfrm>
            <a:off x="4641840" y="1562040"/>
            <a:ext cx="1411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直線コネクタ 103"/>
          <p:cNvSpPr/>
          <p:nvPr/>
        </p:nvSpPr>
        <p:spPr>
          <a:xfrm>
            <a:off x="4357800" y="3627360"/>
            <a:ext cx="1429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直線コネクタ 104"/>
          <p:cNvSpPr/>
          <p:nvPr/>
        </p:nvSpPr>
        <p:spPr>
          <a:xfrm>
            <a:off x="4429080" y="3627360"/>
            <a:ext cx="0" cy="64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正方形/長方形 105"/>
          <p:cNvSpPr/>
          <p:nvPr/>
        </p:nvSpPr>
        <p:spPr>
          <a:xfrm>
            <a:off x="4570560" y="1641600"/>
            <a:ext cx="284040" cy="209232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正方形/長方形 106"/>
          <p:cNvSpPr/>
          <p:nvPr/>
        </p:nvSpPr>
        <p:spPr>
          <a:xfrm>
            <a:off x="4287960" y="3633840"/>
            <a:ext cx="282600" cy="100080"/>
          </a:xfrm>
          <a:prstGeom prst="rect">
            <a:avLst/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直線コネクタ 107"/>
          <p:cNvSpPr/>
          <p:nvPr/>
        </p:nvSpPr>
        <p:spPr>
          <a:xfrm>
            <a:off x="4713120" y="1562040"/>
            <a:ext cx="0" cy="795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直線コネクタ 112"/>
          <p:cNvSpPr/>
          <p:nvPr/>
        </p:nvSpPr>
        <p:spPr>
          <a:xfrm>
            <a:off x="5273640" y="3627360"/>
            <a:ext cx="1414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直線コネクタ 113"/>
          <p:cNvSpPr/>
          <p:nvPr/>
        </p:nvSpPr>
        <p:spPr>
          <a:xfrm>
            <a:off x="5343480" y="3627360"/>
            <a:ext cx="0" cy="32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正方形/長方形 114"/>
          <p:cNvSpPr/>
          <p:nvPr/>
        </p:nvSpPr>
        <p:spPr>
          <a:xfrm>
            <a:off x="5486400" y="3195720"/>
            <a:ext cx="285840" cy="53820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正方形/長方形 115"/>
          <p:cNvSpPr/>
          <p:nvPr/>
        </p:nvSpPr>
        <p:spPr>
          <a:xfrm>
            <a:off x="5202360" y="3633840"/>
            <a:ext cx="284040" cy="100080"/>
          </a:xfrm>
          <a:prstGeom prst="rect">
            <a:avLst/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直線コネクタ 116"/>
          <p:cNvSpPr/>
          <p:nvPr/>
        </p:nvSpPr>
        <p:spPr>
          <a:xfrm>
            <a:off x="5559480" y="3179880"/>
            <a:ext cx="1396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直線コネクタ 117"/>
          <p:cNvSpPr/>
          <p:nvPr/>
        </p:nvSpPr>
        <p:spPr>
          <a:xfrm>
            <a:off x="5630760" y="3179880"/>
            <a:ext cx="0" cy="61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テキスト ボックス 48"/>
          <p:cNvSpPr/>
          <p:nvPr/>
        </p:nvSpPr>
        <p:spPr>
          <a:xfrm>
            <a:off x="146160" y="139680"/>
            <a:ext cx="231408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. 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Rectangle 4"/>
          <p:cNvSpPr/>
          <p:nvPr/>
        </p:nvSpPr>
        <p:spPr>
          <a:xfrm>
            <a:off x="8102160" y="169920"/>
            <a:ext cx="163440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Harazono Y </a:t>
            </a:r>
            <a:r>
              <a:rPr b="1" i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et al.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3-10T23:46:31Z</dcterms:created>
  <dc:creator>MCG</dc:creator>
  <dc:description/>
  <dc:language>en-US</dc:language>
  <cp:lastModifiedBy>MCG</cp:lastModifiedBy>
  <dcterms:modified xsi:type="dcterms:W3CDTF">2013-03-12T03:30:16Z</dcterms:modified>
  <cp:revision>9</cp:revision>
  <dc:subject/>
  <dc:title>PowerPoint プレゼンテーション</dc:title>
</cp:coreProperties>
</file>